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330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65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37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01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48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51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96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81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95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1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7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734A1-549B-46EE-AAE4-7289B03A47E7}" type="datetimeFigureOut">
              <a:rPr lang="en-US" smtClean="0"/>
              <a:t>4/22/2016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2E20-B9F7-42EA-BB8A-2A52F25001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1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26351" y="1578279"/>
            <a:ext cx="55898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EV 5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Recombinant Fstl1 proteins from different cell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0856078"/>
              </p:ext>
            </p:extLst>
          </p:nvPr>
        </p:nvGraphicFramePr>
        <p:xfrm>
          <a:off x="971600" y="2276872"/>
          <a:ext cx="6984777" cy="1296143"/>
        </p:xfrm>
        <a:graphic>
          <a:graphicData uri="http://schemas.openxmlformats.org/drawingml/2006/table">
            <a:tbl>
              <a:tblPr firstRow="1" bandRow="1"/>
              <a:tblGrid>
                <a:gridCol w="311519"/>
                <a:gridCol w="1265689"/>
                <a:gridCol w="1351892"/>
                <a:gridCol w="1464550"/>
                <a:gridCol w="2591127"/>
              </a:tblGrid>
              <a:tr h="2410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urce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ag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ndor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7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uman Fstl1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K29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 tag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os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Inc.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r Walsh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boratory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7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use Fstl1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use cell line 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His in C-term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&amp;D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ystem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7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use Fstl1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sect sf9 cell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AG in C-term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alsh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boratory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7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uman Fstl1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. coli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His in N-term 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viscera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Bioscienc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5292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7</TotalTime>
  <Words>61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Company>b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57</cp:revision>
  <cp:lastPrinted>2015-12-11T18:55:13Z</cp:lastPrinted>
  <dcterms:created xsi:type="dcterms:W3CDTF">2015-07-06T18:02:00Z</dcterms:created>
  <dcterms:modified xsi:type="dcterms:W3CDTF">2016-04-22T13:38:27Z</dcterms:modified>
</cp:coreProperties>
</file>